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966" autoAdjust="0"/>
    <p:restoredTop sz="93945"/>
  </p:normalViewPr>
  <p:slideViewPr>
    <p:cSldViewPr snapToGrid="0" snapToObjects="1">
      <p:cViewPr varScale="1">
        <p:scale>
          <a:sx n="69" d="100"/>
          <a:sy n="69" d="100"/>
        </p:scale>
        <p:origin x="31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450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38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55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194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669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14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3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159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64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719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95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444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19D9E8E9-8A6B-804D-AD74-95014C098799}"/>
              </a:ext>
            </a:extLst>
          </p:cNvPr>
          <p:cNvSpPr txBox="1"/>
          <p:nvPr/>
        </p:nvSpPr>
        <p:spPr>
          <a:xfrm>
            <a:off x="157163" y="35290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E126C02-00CB-4E41-92CC-E0F53477F1D9}"/>
              </a:ext>
            </a:extLst>
          </p:cNvPr>
          <p:cNvSpPr txBox="1"/>
          <p:nvPr/>
        </p:nvSpPr>
        <p:spPr>
          <a:xfrm>
            <a:off x="125198" y="6367176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366272A0-70B1-4047-935A-4965721B3FDB}"/>
              </a:ext>
            </a:extLst>
          </p:cNvPr>
          <p:cNvSpPr/>
          <p:nvPr/>
        </p:nvSpPr>
        <p:spPr>
          <a:xfrm>
            <a:off x="157163" y="9136086"/>
            <a:ext cx="6548437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0"/>
              </a:spcAft>
            </a:pPr>
            <a:r>
              <a:rPr lang="en-CA" sz="14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8: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ximum likelihood amino acid replicase phylogeny of (a)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cute bee paralysis virus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139 amino acids, JTT+G model) and (b) </a:t>
            </a:r>
            <a:r>
              <a:rPr lang="en-US" sz="1400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ack queen cell virus </a:t>
            </a:r>
            <a:r>
              <a:rPr lang="en-US" sz="14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8,683 aa, GTR+G+I model). GenBank accessions are shown in Table S2.</a:t>
            </a:r>
            <a:endParaRPr lang="fr-FR" sz="1400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77968A64-3C42-4333-8844-94CD3623C1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6494" y="1"/>
            <a:ext cx="5002197" cy="6127708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45E0A3C7-EBE9-4E3A-BEBC-E5635CD41C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0512" y="6276878"/>
            <a:ext cx="4863651" cy="2944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3652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9</TotalTime>
  <Words>56</Words>
  <Application>Microsoft Office PowerPoint</Application>
  <PresentationFormat>Format A4 (210 x 297 mm)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ne Dalmon</cp:lastModifiedBy>
  <cp:revision>41</cp:revision>
  <dcterms:created xsi:type="dcterms:W3CDTF">2019-01-23T12:04:28Z</dcterms:created>
  <dcterms:modified xsi:type="dcterms:W3CDTF">2019-07-19T16:45:31Z</dcterms:modified>
</cp:coreProperties>
</file>